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41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723" autoAdjust="0"/>
    <p:restoredTop sz="88632" autoAdjust="0"/>
  </p:normalViewPr>
  <p:slideViewPr>
    <p:cSldViewPr snapToGrid="0" snapToObjects="1">
      <p:cViewPr>
        <p:scale>
          <a:sx n="70" d="100"/>
          <a:sy n="70" d="100"/>
        </p:scale>
        <p:origin x="-2292" y="108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21B3F9F-F21E-493F-BFEA-F1D2D09CFAD3}" type="datetimeFigureOut">
              <a:rPr lang="en-CA" smtClean="0"/>
              <a:pPr/>
              <a:t>22/05/2015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9345854-6294-413A-9C21-02DA63F77C4A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515077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9345854-6294-413A-9C21-02DA63F77C4A}" type="slidenum">
              <a:rPr lang="en-CA" smtClean="0"/>
              <a:pPr/>
              <a:t>1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295823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09490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06570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47894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82603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29210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34309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54862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67428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86149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57022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17932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30677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5" Type="http://schemas.openxmlformats.org/officeDocument/2006/relationships/image" Target="../media/image13.tiff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715688" y="2880066"/>
            <a:ext cx="3223552" cy="3520542"/>
            <a:chOff x="1267244" y="1773327"/>
            <a:chExt cx="3223552" cy="3520542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731783" y="2001363"/>
              <a:ext cx="687600" cy="687600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729108" y="2691029"/>
              <a:ext cx="687600" cy="687600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729005" y="3378629"/>
              <a:ext cx="687600" cy="687600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725672" y="4069284"/>
              <a:ext cx="687600" cy="687600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405748" y="2006647"/>
              <a:ext cx="687600" cy="687600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407079" y="2690813"/>
              <a:ext cx="687600" cy="687600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2402654" y="3379789"/>
              <a:ext cx="687600" cy="687600"/>
            </a:xfrm>
            <a:prstGeom prst="rect">
              <a:avLst/>
            </a:prstGeom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2397122" y="4064066"/>
              <a:ext cx="687600" cy="687600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3096365" y="2003979"/>
              <a:ext cx="687600" cy="687600"/>
            </a:xfrm>
            <a:prstGeom prst="rect">
              <a:avLst/>
            </a:prstGeom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3099387" y="2691802"/>
              <a:ext cx="687600" cy="687600"/>
            </a:xfrm>
            <a:prstGeom prst="rect">
              <a:avLst/>
            </a:prstGeom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3099473" y="3378187"/>
              <a:ext cx="687600" cy="687600"/>
            </a:xfrm>
            <a:prstGeom prst="rect">
              <a:avLst/>
            </a:prstGeom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3099473" y="4065787"/>
              <a:ext cx="687600" cy="687600"/>
            </a:xfrm>
            <a:prstGeom prst="rect">
              <a:avLst/>
            </a:prstGeom>
          </p:spPr>
        </p:pic>
        <p:sp>
          <p:nvSpPr>
            <p:cNvPr id="17" name="TextBox 16"/>
            <p:cNvSpPr txBox="1"/>
            <p:nvPr/>
          </p:nvSpPr>
          <p:spPr>
            <a:xfrm>
              <a:off x="1486936" y="4746914"/>
              <a:ext cx="5404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722164" y="4749174"/>
              <a:ext cx="50593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1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894314" y="4747913"/>
              <a:ext cx="5404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2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2055451" y="4745533"/>
              <a:ext cx="5404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3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2214034" y="4745307"/>
              <a:ext cx="5404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4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1483325" y="4519482"/>
              <a:ext cx="50593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1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1486936" y="4354535"/>
              <a:ext cx="5404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2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1482757" y="4186786"/>
              <a:ext cx="5404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3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1486288" y="4020878"/>
              <a:ext cx="5404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4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26" name="Group 51"/>
            <p:cNvGrpSpPr/>
            <p:nvPr/>
          </p:nvGrpSpPr>
          <p:grpSpPr>
            <a:xfrm>
              <a:off x="1497072" y="4590448"/>
              <a:ext cx="457200" cy="457200"/>
              <a:chOff x="609590" y="2083234"/>
              <a:chExt cx="457200" cy="457200"/>
            </a:xfrm>
          </p:grpSpPr>
          <p:cxnSp>
            <p:nvCxnSpPr>
              <p:cNvPr id="48" name="Straight Arrow Connector 47"/>
              <p:cNvCxnSpPr/>
              <p:nvPr/>
            </p:nvCxnSpPr>
            <p:spPr>
              <a:xfrm>
                <a:off x="609590" y="2533650"/>
                <a:ext cx="457200" cy="1588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Straight Arrow Connector 48"/>
              <p:cNvCxnSpPr/>
              <p:nvPr/>
            </p:nvCxnSpPr>
            <p:spPr>
              <a:xfrm rot="5400000" flipH="1" flipV="1">
                <a:off x="389284" y="2311040"/>
                <a:ext cx="457200" cy="1588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7" name="TextBox 26"/>
            <p:cNvSpPr txBox="1"/>
            <p:nvPr/>
          </p:nvSpPr>
          <p:spPr>
            <a:xfrm>
              <a:off x="1422895" y="5047648"/>
              <a:ext cx="7746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CD25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 rot="16200000">
              <a:off x="1003048" y="4548486"/>
              <a:ext cx="7746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CD4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1880767" y="1773332"/>
              <a:ext cx="7746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NP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2355778" y="1773327"/>
              <a:ext cx="107257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MOG</a:t>
              </a:r>
              <a:r>
                <a:rPr lang="en-US" sz="1000" baseline="30000" dirty="0" smtClean="0">
                  <a:latin typeface="Arial" pitchFamily="34" charset="0"/>
                  <a:cs typeface="Arial" pitchFamily="34" charset="0"/>
                </a:rPr>
                <a:t>35-55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3108099" y="1773327"/>
              <a:ext cx="10260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MOG</a:t>
              </a:r>
              <a:r>
                <a:rPr lang="en-US" sz="1000" baseline="30000" dirty="0" smtClean="0">
                  <a:latin typeface="Arial" pitchFamily="34" charset="0"/>
                  <a:cs typeface="Arial" pitchFamily="34" charset="0"/>
                </a:rPr>
                <a:t>1-125</a:t>
              </a:r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 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3713542" y="2249110"/>
              <a:ext cx="7746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WT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3716182" y="4231424"/>
              <a:ext cx="7746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Cat S</a:t>
              </a:r>
              <a:r>
                <a:rPr lang="en-US" sz="1000" baseline="30000" dirty="0" smtClean="0">
                  <a:latin typeface="Arial" pitchFamily="34" charset="0"/>
                  <a:cs typeface="Arial" pitchFamily="34" charset="0"/>
                </a:rPr>
                <a:t>-/-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1960040" y="2007545"/>
              <a:ext cx="675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2.13%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2629183" y="1989078"/>
              <a:ext cx="675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44.4%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3300948" y="1987863"/>
              <a:ext cx="675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40.7%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3697017" y="3535060"/>
              <a:ext cx="7746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Cat L</a:t>
              </a:r>
              <a:r>
                <a:rPr lang="en-US" sz="1000" baseline="30000" dirty="0" smtClean="0">
                  <a:latin typeface="Arial" pitchFamily="34" charset="0"/>
                  <a:cs typeface="Arial" pitchFamily="34" charset="0"/>
                </a:rPr>
                <a:t>-/-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3691179" y="2869491"/>
              <a:ext cx="7746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Cat B</a:t>
              </a:r>
              <a:r>
                <a:rPr lang="en-US" sz="1000" baseline="30000" dirty="0" smtClean="0">
                  <a:latin typeface="Arial" pitchFamily="34" charset="0"/>
                  <a:cs typeface="Arial" pitchFamily="34" charset="0"/>
                </a:rPr>
                <a:t>-/-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3355107" y="4041511"/>
              <a:ext cx="675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45.2%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2661714" y="4079493"/>
              <a:ext cx="675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46.4%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2010157" y="4052400"/>
              <a:ext cx="675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2.88%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3326825" y="3350046"/>
              <a:ext cx="675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43.5%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2669737" y="3362150"/>
              <a:ext cx="675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45.8%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1975050" y="3343683"/>
              <a:ext cx="675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2.54%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3313320" y="2688101"/>
              <a:ext cx="675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4</a:t>
              </a:r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6.9%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2695615" y="2708831"/>
              <a:ext cx="675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49.0%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1975050" y="2698990"/>
              <a:ext cx="675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2.45%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50" name="TextBox 49"/>
          <p:cNvSpPr txBox="1"/>
          <p:nvPr/>
        </p:nvSpPr>
        <p:spPr>
          <a:xfrm>
            <a:off x="582429" y="6414256"/>
            <a:ext cx="5948227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4 Fig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nalysis of antigen presentation using CD25 as an alternative marker for CD4+ T cell activation generated equivalent results to those found via evaluation of CD69 expression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T, WT LHVS treated, cathepsin B (Cat B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, cathepsin S (Cat S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, cathepsin L (Cat L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, or cathepsin B and S (Cat B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deficient BMMØ were incubated for 6 h with </a:t>
            </a:r>
            <a:r>
              <a:rPr lang="en-CA" sz="1000" dirty="0">
                <a:latin typeface="Arial" panose="020B0604020202020204" pitchFamily="34" charset="0"/>
                <a:cs typeface="Arial" panose="020B0604020202020204" pitchFamily="34" charset="0"/>
              </a:rPr>
              <a:t>MOG</a:t>
            </a:r>
            <a:r>
              <a:rPr lang="en-CA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35-55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peptide (0, 1, 10, 25 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/ml) or MOG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1-125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0, 1, 10, 25 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/ml). Activation of </a:t>
            </a:r>
            <a:r>
              <a:rPr lang="en-CA" sz="1000" dirty="0">
                <a:latin typeface="Arial" panose="020B0604020202020204" pitchFamily="34" charset="0"/>
                <a:cs typeface="Arial" panose="020B0604020202020204" pitchFamily="34" charset="0"/>
              </a:rPr>
              <a:t>MOG</a:t>
            </a:r>
            <a:r>
              <a:rPr lang="en-CA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35-55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specific 2D2 CD4+ T cells was determined by surface expression of CD25 after 16 h exposure to the BMMØs. Representative flow cytometry plots for WT, cathepsin B (Cat B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, cathepsin S (Cat S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, cathepsin L (Cat L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deficient BMMØ incubated with MOG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35-55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25 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/ml ) or MOG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1-125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25 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/ml). </a:t>
            </a:r>
            <a:r>
              <a:rPr lang="en-CA" sz="1000" dirty="0">
                <a:latin typeface="Arial" panose="020B0604020202020204" pitchFamily="34" charset="0"/>
                <a:cs typeface="Arial" panose="020B0604020202020204" pitchFamily="34" charset="0"/>
              </a:rPr>
              <a:t>Data represent 3 independent experiments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Data presented as mean +/- SEM (</a:t>
            </a:r>
            <a:r>
              <a:rPr lang="en-CA" sz="1000" dirty="0">
                <a:latin typeface="Arial" panose="020B0604020202020204" pitchFamily="34" charset="0"/>
                <a:cs typeface="Arial" panose="020B0604020202020204" pitchFamily="34" charset="0"/>
              </a:rPr>
              <a:t>ANOVA, p&lt;0.05); significant differences from internal WT controls are denoted by asterisks (*). </a:t>
            </a:r>
          </a:p>
        </p:txBody>
      </p:sp>
      <p:pic>
        <p:nvPicPr>
          <p:cNvPr id="3074" name="Picture 2" descr="C:\Users\Euan\Desktop\Euan's LAB NEW\Manuscripts\CAT EAE Manuscript\CAT BSL Paper\Prizm FIles\High Res pannels\S4 a peptide dose cd25.tif"/>
          <p:cNvPicPr>
            <a:picLocks noChangeAspect="1"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5475" y="627799"/>
            <a:ext cx="2990088" cy="17282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5" name="Picture 3" descr="C:\Users\Euan\Desktop\Euan's LAB NEW\Manuscripts\CAT EAE Manuscript\CAT BSL Paper\Prizm FIles\High Res pannels\S4 b rmog dose cd25.tif"/>
          <p:cNvPicPr>
            <a:picLocks noChangeAspect="1"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48660" y="627799"/>
            <a:ext cx="2990088" cy="17282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6064969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093</TotalTime>
  <Words>243</Words>
  <Application>Microsoft Office PowerPoint</Application>
  <PresentationFormat>On-screen Show (4:3)</PresentationFormat>
  <Paragraphs>32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istrator</dc:creator>
  <cp:lastModifiedBy>Euan</cp:lastModifiedBy>
  <cp:revision>1550</cp:revision>
  <dcterms:created xsi:type="dcterms:W3CDTF">2012-09-11T17:14:12Z</dcterms:created>
  <dcterms:modified xsi:type="dcterms:W3CDTF">2015-05-22T19:08:07Z</dcterms:modified>
</cp:coreProperties>
</file>